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1" r:id="rId4"/>
    <p:sldId id="262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5" d="100"/>
          <a:sy n="85" d="100"/>
        </p:scale>
        <p:origin x="58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010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5572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6593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8649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4862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5034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3713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6593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3673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8859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418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6A34B-E379-407A-BE86-0F71E2C64E66}" type="datetimeFigureOut">
              <a:rPr lang="ko-KR" altLang="en-US" smtClean="0"/>
              <a:t>2019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22040-CCC6-4D9C-A599-FD7F464F88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83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3850852"/>
              </p:ext>
            </p:extLst>
          </p:nvPr>
        </p:nvGraphicFramePr>
        <p:xfrm>
          <a:off x="4408863" y="1987409"/>
          <a:ext cx="3984899" cy="23834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Prism Project" r:id="rId3" imgW="4392000" imgH="2628000" progId="Prism5.Document">
                  <p:embed/>
                </p:oleObj>
              </mc:Choice>
              <mc:Fallback>
                <p:oleObj name="Prism Project" r:id="rId3" imgW="4392000" imgH="2628000" progId="Prism5.Document">
                  <p:embed/>
                  <p:pic>
                    <p:nvPicPr>
                      <p:cNvPr id="2" name="개체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08863" y="1987409"/>
                        <a:ext cx="3984899" cy="23834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-119878" y="-17515"/>
            <a:ext cx="1409480" cy="343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1"/>
            <a:r>
              <a:rPr lang="en-US" altLang="ko-KR" sz="1633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endParaRPr lang="ko-KR" altLang="ko-KR" sz="16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B5CDE8F6-A6A8-4C40-8EDD-6B933F37BDC1}"/>
              </a:ext>
            </a:extLst>
          </p:cNvPr>
          <p:cNvSpPr/>
          <p:nvPr/>
        </p:nvSpPr>
        <p:spPr>
          <a:xfrm>
            <a:off x="276224" y="4963784"/>
            <a:ext cx="11782425" cy="7741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200000"/>
              </a:lnSpc>
              <a:spcAft>
                <a:spcPts val="800"/>
              </a:spcAft>
            </a:pP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high concentration of TST shows the toxicity of ZF survival. Kaplan-Meier larvae survival curves following treatment at 3 </a:t>
            </a:r>
            <a:r>
              <a:rPr lang="en-GB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f</a:t>
            </a:r>
            <a:r>
              <a:rPr lang="en-GB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ST 1, 10, 20, 40 and 80 µM. The data were representative of three replicates, with 7 ZF per condition per replicate. ZF survival was observed for survival at 6 days regular intervals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6676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19878" y="-17515"/>
            <a:ext cx="1409480" cy="343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1"/>
            <a:r>
              <a:rPr lang="en-US" altLang="ko-KR" sz="1633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endParaRPr lang="ko-KR" altLang="ko-KR" sz="16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57EA00D6-0742-4000-B4B2-DC8BC7F10A68}"/>
              </a:ext>
            </a:extLst>
          </p:cNvPr>
          <p:cNvSpPr/>
          <p:nvPr/>
        </p:nvSpPr>
        <p:spPr>
          <a:xfrm>
            <a:off x="2191870" y="5669879"/>
            <a:ext cx="7808259" cy="4048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latinLnBrk="0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-UV chromatograms of the blank ZF extract (A) and the extract sample from ZF treated with TST (B)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5" name="Picture 2">
            <a:extLst>
              <a:ext uri="{FF2B5EF4-FFF2-40B4-BE49-F238E27FC236}">
                <a16:creationId xmlns:a16="http://schemas.microsoft.com/office/drawing/2014/main" id="{11A092F8-1EC9-434B-9D09-04C70C891A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8889" y="532280"/>
            <a:ext cx="5400000" cy="2544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B99AF3B-A6EB-4175-8C39-21F7F4D79651}"/>
              </a:ext>
            </a:extLst>
          </p:cNvPr>
          <p:cNvSpPr txBox="1"/>
          <p:nvPr/>
        </p:nvSpPr>
        <p:spPr>
          <a:xfrm>
            <a:off x="2599652" y="472905"/>
            <a:ext cx="398939" cy="287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7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27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3">
            <a:extLst>
              <a:ext uri="{FF2B5EF4-FFF2-40B4-BE49-F238E27FC236}">
                <a16:creationId xmlns:a16="http://schemas.microsoft.com/office/drawing/2014/main" id="{CBEEC9D1-C641-4767-8453-A4E5515D571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5784" y="3059782"/>
            <a:ext cx="5400000" cy="2555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7725A91-1D74-40DB-ADB2-F48A661D09BF}"/>
              </a:ext>
            </a:extLst>
          </p:cNvPr>
          <p:cNvSpPr txBox="1"/>
          <p:nvPr/>
        </p:nvSpPr>
        <p:spPr>
          <a:xfrm>
            <a:off x="2598915" y="3027497"/>
            <a:ext cx="398939" cy="287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7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27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85705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1"/>
          <p:cNvPicPr/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29291"/>
            <a:ext cx="6756400" cy="2447888"/>
          </a:xfrm>
          <a:prstGeom prst="rect">
            <a:avLst/>
          </a:prstGeom>
          <a:noFill/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1931" y="665228"/>
            <a:ext cx="4494448" cy="337601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-119878" y="-17515"/>
            <a:ext cx="1409480" cy="343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1"/>
            <a:r>
              <a:rPr lang="en-US" altLang="ko-KR" sz="1633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endParaRPr lang="ko-KR" altLang="ko-KR" sz="16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28782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478208A1-49B0-47A2-A084-C4E59AC8AB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647" y="1008708"/>
            <a:ext cx="4645152" cy="3029712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1F0AAB47-9084-448C-9A2E-E0A66A1C0F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4723" y="1008708"/>
            <a:ext cx="4675632" cy="302971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E97085B-795E-4E34-BB0D-81BEF95B73B5}"/>
              </a:ext>
            </a:extLst>
          </p:cNvPr>
          <p:cNvSpPr txBox="1"/>
          <p:nvPr/>
        </p:nvSpPr>
        <p:spPr>
          <a:xfrm>
            <a:off x="-119878" y="-17515"/>
            <a:ext cx="1409480" cy="343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latinLnBrk="1"/>
            <a:r>
              <a:rPr lang="en-US" altLang="ko-KR" sz="1633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endParaRPr lang="ko-KR" altLang="ko-KR" sz="16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900BF2C9-FA3B-45E4-8D52-75FCE35DA98D}"/>
              </a:ext>
            </a:extLst>
          </p:cNvPr>
          <p:cNvSpPr/>
          <p:nvPr/>
        </p:nvSpPr>
        <p:spPr>
          <a:xfrm>
            <a:off x="753036" y="4326838"/>
            <a:ext cx="10820400" cy="18826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aluati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vo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ST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IP 104536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photyp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n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Wasabi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ecti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ng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Wasabi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≈400 CFU)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ec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a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udal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i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ecti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sualiz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rug-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bryo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l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ad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ST, and CLA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bryo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ult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g10 CFU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bryo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-infec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bryo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and 5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ST (C) and CLA (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is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ec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bryo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n-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0,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ce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***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)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ST,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ostrepto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LA, </a:t>
            </a:r>
            <a:r>
              <a:rPr lang="ko-KR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rithromycin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00263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</TotalTime>
  <Words>232</Words>
  <Application>Microsoft Office PowerPoint</Application>
  <PresentationFormat>와이드스크린</PresentationFormat>
  <Paragraphs>9</Paragraphs>
  <Slides>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Prism Project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장 지찬</cp:lastModifiedBy>
  <cp:revision>15</cp:revision>
  <dcterms:created xsi:type="dcterms:W3CDTF">2019-05-20T07:40:32Z</dcterms:created>
  <dcterms:modified xsi:type="dcterms:W3CDTF">2019-11-22T07:39:21Z</dcterms:modified>
</cp:coreProperties>
</file>